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9" r:id="rId3"/>
    <p:sldId id="260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41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38078" y="685056"/>
            <a:ext cx="2781845" cy="342953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A253F9-E33B-493C-A1DA-EF32D2919522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1A3264-7EE1-4DE3-8345-B95424AF947F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70087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6794137"/>
              </p:ext>
            </p:extLst>
          </p:nvPr>
        </p:nvGraphicFramePr>
        <p:xfrm>
          <a:off x="95736" y="395536"/>
          <a:ext cx="6720624" cy="283879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599944"/>
                <a:gridCol w="445451"/>
                <a:gridCol w="851347"/>
                <a:gridCol w="1566872"/>
                <a:gridCol w="577269"/>
                <a:gridCol w="329867"/>
                <a:gridCol w="412335"/>
                <a:gridCol w="412335"/>
                <a:gridCol w="412335"/>
                <a:gridCol w="1112869"/>
              </a:tblGrid>
              <a:tr h="219796"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Ethnicity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Sputum smear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CXR result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Symptoms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Symptom length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CRP</a:t>
                      </a:r>
                    </a:p>
                    <a:p>
                      <a:pPr algn="ctr" rtl="0" fontAlgn="t"/>
                      <a:r>
                        <a:rPr lang="en-GB" sz="900" u="none" strike="noStrike" dirty="0" smtClean="0">
                          <a:effectLst/>
                        </a:rPr>
                        <a:t>mg/L</a:t>
                      </a:r>
                      <a:r>
                        <a:rPr lang="en-GB" sz="1000" u="none" strike="noStrike" dirty="0" smtClean="0"/>
                        <a:t>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Lymph</a:t>
                      </a:r>
                    </a:p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err="1" smtClean="0"/>
                        <a:t>Neut</a:t>
                      </a:r>
                      <a:endParaRPr lang="en-GB" sz="1000" u="none" strike="noStrike" dirty="0" smtClean="0"/>
                    </a:p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IGRA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Other 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35830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Density </a:t>
                      </a:r>
                      <a:r>
                        <a:rPr lang="en-GB" sz="900" u="none" strike="noStrike" dirty="0"/>
                        <a:t>&amp; </a:t>
                      </a:r>
                      <a:r>
                        <a:rPr lang="en-GB" sz="900" u="none" strike="noStrike" dirty="0" smtClean="0"/>
                        <a:t>cav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Cough, sweat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01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6.8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+ve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8331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Black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Density </a:t>
                      </a:r>
                      <a:r>
                        <a:rPr lang="en-GB" sz="900" u="none" strike="noStrike" dirty="0"/>
                        <a:t>&amp; </a:t>
                      </a:r>
                      <a:r>
                        <a:rPr lang="en-GB" sz="900" u="none" strike="noStrike" dirty="0" smtClean="0"/>
                        <a:t>cav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Cough, sweat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5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3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9.5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+v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/>
                        <a:t>Previous </a:t>
                      </a:r>
                      <a:r>
                        <a:rPr lang="en-GB" sz="900" u="none" strike="noStrike" dirty="0" smtClean="0"/>
                        <a:t>TB, smoker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8331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Black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Density </a:t>
                      </a:r>
                      <a:r>
                        <a:rPr lang="en-GB" sz="900" u="none" strike="noStrike" dirty="0"/>
                        <a:t>&amp; </a:t>
                      </a:r>
                      <a:r>
                        <a:rPr lang="en-GB" sz="900" u="none" strike="noStrike" dirty="0" smtClean="0"/>
                        <a:t>cav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weight loss, swea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2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7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22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4.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8331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ISC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 </a:t>
                      </a:r>
                      <a:r>
                        <a:rPr lang="en-GB" sz="900" u="none" strike="noStrike" dirty="0"/>
                        <a:t>&amp; </a:t>
                      </a:r>
                      <a:r>
                        <a:rPr lang="en-GB" sz="900" u="none" strike="noStrike" dirty="0" smtClean="0"/>
                        <a:t>cav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65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6.8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 smtClean="0"/>
                        <a:t>Diabetic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weight los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9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7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3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6.7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 smtClean="0"/>
                        <a:t>Heavy</a:t>
                      </a:r>
                      <a:r>
                        <a:rPr lang="en-GB" sz="900" u="none" strike="noStrike" baseline="0" dirty="0" smtClean="0"/>
                        <a:t> s</a:t>
                      </a:r>
                      <a:r>
                        <a:rPr lang="en-GB" sz="900" u="none" strike="noStrike" dirty="0" smtClean="0"/>
                        <a:t>moker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35819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ISC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Y (BAL)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weight loss, swea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3 month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6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17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7.9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Black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swea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8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48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7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171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Black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weight loss, swea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 month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5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57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.52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4726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Black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 </a:t>
                      </a:r>
                      <a:r>
                        <a:rPr lang="en-GB" sz="900" u="none" strike="noStrike" dirty="0" smtClean="0"/>
                        <a:t>&amp; cavitie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Cough, weight loss, sweat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 month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3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0.05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171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ISC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Y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Cough, weight loss, sweat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 month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5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7.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ISC</a:t>
                      </a:r>
                      <a:endParaRPr lang="en-GB" sz="900" b="0" i="0" u="none" strike="noStrike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ormal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Weight loss, sweat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21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5.38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ISC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Cavitation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Cough, sweat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24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4.93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/>
                        <a:t>Alcohol excess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/>
                        <a:t>Y (BAL) </a:t>
                      </a:r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/>
                        <a:t> </a:t>
                      </a:r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r>
                        <a:rPr lang="en-GB" sz="900" u="none" strike="noStrike" dirty="0" smtClean="0"/>
                        <a:t>Cough, sweats, weight los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N/A</a:t>
                      </a:r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8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/>
                        <a:t>Alcohol excess </a:t>
                      </a:r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 smtClean="0"/>
                        <a:t>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 </a:t>
                      </a:r>
                      <a:r>
                        <a:rPr lang="en-GB" sz="900" u="none" strike="noStrike" dirty="0" smtClean="0"/>
                        <a:t>&amp; cav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r>
                        <a:rPr lang="en-GB" sz="900" u="none" strike="noStrike" dirty="0" smtClean="0"/>
                        <a:t>Cough, sweats,</a:t>
                      </a:r>
                      <a:r>
                        <a:rPr lang="en-GB" sz="900" u="none" strike="noStrike" baseline="0" dirty="0" smtClean="0"/>
                        <a:t> weight los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/>
                        <a:t> </a:t>
                      </a:r>
                      <a:r>
                        <a:rPr lang="en-GB" sz="900" u="none" strike="noStrike" dirty="0" smtClean="0"/>
                        <a:t>N/A </a:t>
                      </a:r>
                      <a:endParaRPr lang="en-GB" sz="9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5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7.8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 smtClean="0"/>
                        <a:t>Smoker</a:t>
                      </a:r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 smtClean="0"/>
                        <a:t>Y</a:t>
                      </a:r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 </a:t>
                      </a:r>
                      <a:r>
                        <a:rPr lang="en-GB" sz="900" u="none" strike="noStrike" dirty="0" smtClean="0"/>
                        <a:t>&amp; cav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r>
                        <a:rPr lang="en-GB" sz="900" u="none" strike="noStrike" dirty="0" smtClean="0"/>
                        <a:t>Cough, sweats, weight los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/>
                        <a:t>N/A </a:t>
                      </a:r>
                      <a:endParaRPr lang="en-GB" sz="9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7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2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7.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 smtClean="0"/>
                        <a:t>Asthma</a:t>
                      </a:r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 smtClean="0"/>
                        <a:t>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/>
                        <a:t> </a:t>
                      </a:r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r>
                        <a:rPr lang="en-GB" sz="900" u="none" strike="noStrike" dirty="0" smtClean="0"/>
                        <a:t>Cough, sweats,</a:t>
                      </a:r>
                      <a:r>
                        <a:rPr lang="en-GB" sz="900" u="none" strike="noStrike" baseline="0" dirty="0" smtClean="0"/>
                        <a:t> weight los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/>
                        <a:t>N/A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5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7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4.1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+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r>
                        <a:rPr lang="en-GB" sz="900" u="none" strike="noStrike" dirty="0" smtClean="0"/>
                        <a:t>Previous TB, smoker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949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AVERAGE</a:t>
                      </a:r>
                      <a:endParaRPr lang="en-GB" sz="1050" b="1" i="0" u="none" strike="noStrike" dirty="0"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1050" u="none" strike="noStrike" dirty="0" smtClean="0"/>
                        <a:t>2.5</a:t>
                      </a:r>
                      <a:r>
                        <a:rPr lang="en-GB" sz="1050" u="none" strike="noStrike" baseline="0" dirty="0" smtClean="0"/>
                        <a:t> symptom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4 </a:t>
                      </a:r>
                      <a:r>
                        <a:rPr lang="en-GB" sz="1050" u="none" strike="noStrike" dirty="0" err="1" smtClean="0"/>
                        <a:t>mnth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50" u="none" strike="noStrike" dirty="0" smtClean="0"/>
                        <a:t>77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1.2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9525" marR="9525" marT="848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6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9525" marR="9525" marT="848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GB" sz="9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5175390"/>
              </p:ext>
            </p:extLst>
          </p:nvPr>
        </p:nvGraphicFramePr>
        <p:xfrm>
          <a:off x="92752" y="3666497"/>
          <a:ext cx="6720624" cy="4865943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599944"/>
                <a:gridCol w="445451"/>
                <a:gridCol w="851347"/>
                <a:gridCol w="1566872"/>
                <a:gridCol w="577269"/>
                <a:gridCol w="329867"/>
                <a:gridCol w="412335"/>
                <a:gridCol w="412335"/>
                <a:gridCol w="412335"/>
                <a:gridCol w="1112869"/>
              </a:tblGrid>
              <a:tr h="120842"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b="1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Ethnicity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Sputum smear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CXR result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Symptoms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Symptom length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CRP</a:t>
                      </a:r>
                    </a:p>
                    <a:p>
                      <a:pPr algn="ctr" rtl="0" fontAlgn="t"/>
                      <a:r>
                        <a:rPr lang="en-GB" sz="900" u="none" strike="noStrike" dirty="0" smtClean="0">
                          <a:effectLst/>
                        </a:rPr>
                        <a:t>mg/L</a:t>
                      </a:r>
                      <a:r>
                        <a:rPr lang="en-GB" sz="1000" u="none" strike="noStrike" dirty="0" smtClean="0"/>
                        <a:t>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 smtClean="0"/>
                        <a:t>Lymph</a:t>
                      </a:r>
                    </a:p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err="1" smtClean="0"/>
                        <a:t>Neut</a:t>
                      </a:r>
                      <a:endParaRPr lang="en-GB" sz="1000" u="none" strike="noStrike" dirty="0" smtClean="0"/>
                    </a:p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IGRA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1000" u="none" strike="noStrike" dirty="0"/>
                        <a:t>Other 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Black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/>
                        <a:t>-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</a:t>
                      </a:r>
                      <a:r>
                        <a:rPr lang="en-GB" sz="900" u="none" strike="noStrike"/>
                        <a:t>, </a:t>
                      </a:r>
                      <a:r>
                        <a:rPr lang="en-GB" sz="900" u="none" strike="noStrike" smtClean="0"/>
                        <a:t>Dens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 year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3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.8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171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ISC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/>
                        <a:t>-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BHL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err="1"/>
                        <a:t>Cough,fatigue,sweats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 month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3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81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57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ISC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/>
                        <a:t>-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</a:t>
                      </a:r>
                      <a:r>
                        <a:rPr lang="en-GB" sz="900" u="none" strike="noStrike"/>
                        <a:t>, </a:t>
                      </a:r>
                      <a:r>
                        <a:rPr lang="en-GB" sz="900" u="none" strike="noStrike" smtClean="0"/>
                        <a:t>Dens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asymp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92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.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92637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Black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, </a:t>
                      </a:r>
                      <a:r>
                        <a:rPr lang="en-GB" sz="900" u="none" strike="noStrike" dirty="0" smtClean="0"/>
                        <a:t>Dens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</a:t>
                      </a:r>
                      <a:r>
                        <a:rPr lang="en-GB" sz="900" u="none" strike="noStrike" dirty="0" smtClean="0"/>
                        <a:t>dyspnoea, </a:t>
                      </a:r>
                      <a:r>
                        <a:rPr lang="en-GB" sz="900" u="none" strike="noStrike" dirty="0"/>
                        <a:t>fatigue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 year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18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43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Psoriasis, 5mg </a:t>
                      </a:r>
                      <a:r>
                        <a:rPr lang="en-GB" sz="900" u="none" strike="noStrike" dirty="0" err="1" smtClean="0"/>
                        <a:t>pred</a:t>
                      </a:r>
                      <a:r>
                        <a:rPr lang="en-GB" sz="900" u="none" strike="noStrike" baseline="0" dirty="0" smtClean="0"/>
                        <a:t> dail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ISC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on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 year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55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Black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Fatigue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0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23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78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ISC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asymp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26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92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92637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Black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/>
                        <a:t>-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</a:t>
                      </a:r>
                      <a:r>
                        <a:rPr lang="en-GB" sz="900" u="none" strike="noStrike" dirty="0" smtClean="0"/>
                        <a:t>dyspnoea, </a:t>
                      </a:r>
                      <a:r>
                        <a:rPr lang="en-GB" sz="900" u="none" strike="noStrike" dirty="0"/>
                        <a:t>fatigue, </a:t>
                      </a:r>
                      <a:r>
                        <a:rPr lang="en-GB" sz="900" u="none" strike="noStrike" dirty="0" smtClean="0"/>
                        <a:t>weight </a:t>
                      </a:r>
                      <a:r>
                        <a:rPr lang="en-GB" sz="900" u="none" strike="noStrike" dirty="0"/>
                        <a:t>loss, sweat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8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7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7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8331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on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6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83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92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Autoimmune disease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19334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on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 month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37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1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Previous </a:t>
                      </a:r>
                      <a:r>
                        <a:rPr lang="en-GB" sz="900" u="none" strike="noStrike" dirty="0" smtClean="0"/>
                        <a:t>cancer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Fatigue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5 year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4.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on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 month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1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6.1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Mild strok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863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3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05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4.53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Diabetes, </a:t>
                      </a:r>
                      <a:r>
                        <a:rPr lang="en-GB" sz="900" u="none" strike="noStrike" dirty="0"/>
                        <a:t>Previous cancer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9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52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1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on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3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.55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22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/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Fatigue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0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68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.15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err="1" smtClean="0"/>
                        <a:t>ind</a:t>
                      </a:r>
                      <a:r>
                        <a:rPr lang="en-GB" sz="900" u="none" strike="noStrike" dirty="0" smtClean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Hypertens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509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 smtClean="0"/>
                        <a:t>-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Fibrosi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</a:t>
                      </a:r>
                      <a:r>
                        <a:rPr lang="en-GB" sz="900" u="none" strike="noStrike" dirty="0" smtClean="0"/>
                        <a:t>dyspnoea, </a:t>
                      </a:r>
                      <a:r>
                        <a:rPr lang="en-GB" sz="900" u="none" strike="noStrike" dirty="0"/>
                        <a:t>fatigue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2 year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23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5.4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Diabetes, Hypertension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</a:t>
                      </a:r>
                      <a:r>
                        <a:rPr lang="en-GB" sz="900" u="none" strike="noStrike"/>
                        <a:t>, </a:t>
                      </a:r>
                      <a:r>
                        <a:rPr lang="en-GB" sz="900" u="none" strike="noStrike" smtClean="0"/>
                        <a:t>Dens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4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43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.73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Gou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Fibrosi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Cough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10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1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99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7.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Glaucom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2416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</a:t>
                      </a:r>
                      <a:r>
                        <a:rPr lang="en-GB" sz="900" u="none" strike="noStrike"/>
                        <a:t>, </a:t>
                      </a:r>
                      <a:r>
                        <a:rPr lang="en-GB" sz="900" u="none" strike="noStrike" smtClean="0"/>
                        <a:t>Dens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</a:t>
                      </a:r>
                      <a:r>
                        <a:rPr lang="en-GB" sz="900" u="none" strike="noStrike" dirty="0" smtClean="0"/>
                        <a:t>dyspnoea, </a:t>
                      </a:r>
                      <a:r>
                        <a:rPr lang="en-GB" sz="900" u="none" strike="noStrike" dirty="0"/>
                        <a:t>fatigue, </a:t>
                      </a:r>
                      <a:r>
                        <a:rPr lang="en-GB" sz="900" u="none" strike="noStrike" dirty="0" smtClean="0"/>
                        <a:t>weight </a:t>
                      </a:r>
                      <a:r>
                        <a:rPr lang="en-GB" sz="900" u="none" strike="noStrike" dirty="0"/>
                        <a:t>los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6 month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6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68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BHL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Non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5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06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2.8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92637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</a:t>
                      </a:r>
                      <a:r>
                        <a:rPr lang="en-GB" sz="900" u="none" strike="noStrike"/>
                        <a:t>, </a:t>
                      </a:r>
                      <a:r>
                        <a:rPr lang="en-GB" sz="900" u="none" strike="noStrike" smtClean="0"/>
                        <a:t>Density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, </a:t>
                      </a:r>
                      <a:r>
                        <a:rPr lang="en-GB" sz="900" u="none" strike="noStrike" dirty="0" smtClean="0"/>
                        <a:t>dyspnoea, </a:t>
                      </a:r>
                      <a:r>
                        <a:rPr lang="en-GB" sz="900" u="none" strike="noStrike" dirty="0"/>
                        <a:t>fatigue, </a:t>
                      </a:r>
                      <a:r>
                        <a:rPr lang="en-GB" sz="900" u="none" strike="noStrike" dirty="0" smtClean="0"/>
                        <a:t>weight </a:t>
                      </a:r>
                      <a:r>
                        <a:rPr lang="en-GB" sz="900" u="none" strike="noStrike" dirty="0"/>
                        <a:t>los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4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 smtClean="0"/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64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3.29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/>
                        <a:t>9 year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65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4.14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31215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Black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/>
                        <a:t>- 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Cough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6 year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97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1.53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/>
                </a:tc>
              </a:tr>
              <a:tr h="120842"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White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GB" sz="900" u="none" strike="noStrike" dirty="0"/>
                        <a:t>-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BHL</a:t>
                      </a:r>
                      <a:r>
                        <a:rPr lang="en-GB" sz="900" u="none" strike="noStrike"/>
                        <a:t>, </a:t>
                      </a:r>
                      <a:r>
                        <a:rPr lang="en-GB" sz="900" u="none" strike="noStrike" smtClean="0"/>
                        <a:t>Density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None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4 year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 </a:t>
                      </a:r>
                      <a:r>
                        <a:rPr lang="en-GB" sz="900" u="none" strike="noStrike" dirty="0" smtClean="0"/>
                        <a:t>ND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/>
                        <a:t>0.61</a:t>
                      </a:r>
                      <a:endParaRPr lang="en-GB" sz="900" b="0" i="0" u="none" strike="noStrike" dirty="0"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 smtClean="0"/>
                        <a:t>2.76</a:t>
                      </a:r>
                      <a:endParaRPr lang="en-GB" sz="900" b="0" i="0" u="none" strike="noStrike" dirty="0">
                        <a:latin typeface="+mn-lt"/>
                      </a:endParaRPr>
                    </a:p>
                  </a:txBody>
                  <a:tcPr marL="9525" marR="9525" marT="848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u="none" strike="noStrike" dirty="0"/>
                        <a:t>-</a:t>
                      </a:r>
                      <a:r>
                        <a:rPr lang="en-GB" sz="900" u="none" strike="noStrike" dirty="0" err="1"/>
                        <a:t>ve</a:t>
                      </a:r>
                      <a:r>
                        <a:rPr lang="en-GB" sz="900" u="none" strike="noStrike" dirty="0"/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900" u="none" strike="noStrike" dirty="0"/>
                        <a:t>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1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AVEARGE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9525" marR="9525" marT="848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50" b="1" i="0" u="none" strike="noStrike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50" u="none" strike="noStrike" dirty="0" smtClean="0"/>
                        <a:t>1 symptom</a:t>
                      </a:r>
                      <a:endParaRPr lang="en-GB" sz="800" b="1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050" u="none" strike="noStrike" dirty="0" smtClean="0"/>
                        <a:t>4</a:t>
                      </a:r>
                      <a:r>
                        <a:rPr lang="en-GB" sz="1050" u="none" strike="noStrike" baseline="0" dirty="0" smtClean="0"/>
                        <a:t> yr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6.3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1.3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848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/>
                        <a:t>3.7</a:t>
                      </a:r>
                      <a:endParaRPr lang="en-GB" sz="1050" b="1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9525" marR="9525" marT="848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105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GB" sz="9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2820" marR="2820" marT="251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-76812" y="-1575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A</a:t>
            </a:r>
            <a:endParaRPr lang="en-GB" b="1" dirty="0"/>
          </a:p>
        </p:txBody>
      </p:sp>
      <p:sp>
        <p:nvSpPr>
          <p:cNvPr id="8" name="TextBox 7"/>
          <p:cNvSpPr txBox="1"/>
          <p:nvPr/>
        </p:nvSpPr>
        <p:spPr>
          <a:xfrm>
            <a:off x="-48859" y="333857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B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332904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4092009"/>
              </p:ext>
            </p:extLst>
          </p:nvPr>
        </p:nvGraphicFramePr>
        <p:xfrm>
          <a:off x="2" y="395536"/>
          <a:ext cx="6857999" cy="3705853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603877"/>
                <a:gridCol w="713270"/>
                <a:gridCol w="792522"/>
                <a:gridCol w="1188783"/>
                <a:gridCol w="634018"/>
                <a:gridCol w="288485"/>
                <a:gridCol w="510396"/>
                <a:gridCol w="340264"/>
                <a:gridCol w="366648"/>
                <a:gridCol w="654142"/>
                <a:gridCol w="765594"/>
              </a:tblGrid>
              <a:tr h="39210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Ethnicity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+ve micro</a:t>
                      </a:r>
                      <a:r>
                        <a:rPr lang="en-GB" sz="1050" u="none" strike="noStrike" dirty="0">
                          <a:effectLst/>
                        </a:rPr>
                        <a:t/>
                      </a:r>
                      <a:br>
                        <a:rPr lang="en-GB" sz="1050" u="none" strike="noStrike" dirty="0">
                          <a:effectLst/>
                        </a:rPr>
                      </a:br>
                      <a:r>
                        <a:rPr lang="en-GB" sz="1050" u="none" strike="noStrike" dirty="0">
                          <a:effectLst/>
                        </a:rPr>
                        <a:t> result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CXR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Symptom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CURB65 score </a:t>
                      </a:r>
                      <a:br>
                        <a:rPr lang="en-GB" sz="1050" u="none" strike="noStrike" dirty="0">
                          <a:effectLst/>
                        </a:rPr>
                      </a:br>
                      <a:r>
                        <a:rPr lang="en-GB" sz="1050" u="none" strike="noStrike" dirty="0" smtClean="0">
                          <a:effectLst/>
                        </a:rPr>
                        <a:t>(0-5</a:t>
                      </a:r>
                      <a:r>
                        <a:rPr lang="en-GB" sz="1050" u="none" strike="noStrike" dirty="0">
                          <a:effectLst/>
                        </a:rPr>
                        <a:t>)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CRP</a:t>
                      </a:r>
                    </a:p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mg/L</a:t>
                      </a:r>
                      <a:endParaRPr lang="en-GB" sz="1050" b="1" i="0" u="none" strike="noStrike" dirty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Lymph</a:t>
                      </a:r>
                    </a:p>
                    <a:p>
                      <a:pPr algn="ctr" fontAlgn="b"/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err="1" smtClean="0">
                          <a:effectLst/>
                        </a:rPr>
                        <a:t>Neut</a:t>
                      </a:r>
                      <a:endParaRPr lang="en-GB" sz="1050" u="none" strike="noStrike" dirty="0" smtClean="0">
                        <a:effectLst/>
                      </a:endParaRP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QFT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Other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Intravenous antibiotics </a:t>
                      </a:r>
                      <a:r>
                        <a:rPr lang="en-GB" sz="1050" u="none" strike="noStrike" dirty="0">
                          <a:effectLst/>
                        </a:rPr>
                        <a:t/>
                      </a:r>
                      <a:br>
                        <a:rPr lang="en-GB" sz="1050" u="none" strike="noStrike" dirty="0">
                          <a:effectLst/>
                        </a:rPr>
                      </a:br>
                      <a:r>
                        <a:rPr lang="en-GB" sz="1050" u="none" strike="noStrike" dirty="0" smtClean="0">
                          <a:effectLst/>
                        </a:rPr>
                        <a:t>before blood</a:t>
                      </a:r>
                      <a:r>
                        <a:rPr lang="en-GB" sz="1050" u="none" strike="noStrike" baseline="0" dirty="0" smtClean="0">
                          <a:effectLst/>
                        </a:rPr>
                        <a:t> test</a:t>
                      </a:r>
                      <a:endParaRPr lang="en-GB" sz="1050" u="none" strike="noStrike" dirty="0" smtClean="0">
                        <a:effectLst/>
                      </a:endParaRPr>
                    </a:p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(total </a:t>
                      </a:r>
                      <a:r>
                        <a:rPr lang="en-GB" sz="1050" u="none" strike="noStrike" dirty="0">
                          <a:effectLst/>
                        </a:rPr>
                        <a:t>doses)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1980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Whi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Mycoplasm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>
                          <a:effectLst/>
                        </a:rPr>
                        <a:t>Multilobar</a:t>
                      </a:r>
                      <a:r>
                        <a:rPr lang="en-GB" sz="1000" u="none" strike="noStrike" dirty="0">
                          <a:effectLst/>
                        </a:rPr>
                        <a:t> </a:t>
                      </a:r>
                      <a:r>
                        <a:rPr lang="en-GB" sz="1000" u="none" strike="noStrike" dirty="0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fever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0.7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5.4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eg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29507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Whi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chest pain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, </a:t>
                      </a:r>
                      <a:r>
                        <a:rPr lang="en-GB" sz="1000" u="none" strike="noStrike" dirty="0">
                          <a:effectLst/>
                        </a:rPr>
                        <a:t>fevers, vomitin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3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8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.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7.3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eg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revious TB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1980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Whit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0.9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9.2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eg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Dementi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29507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Whi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, </a:t>
                      </a:r>
                      <a:r>
                        <a:rPr lang="en-GB" sz="1000" u="none" strike="noStrike" dirty="0">
                          <a:effectLst/>
                        </a:rPr>
                        <a:t>fevers, nause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5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.6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4.0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>
                          <a:effectLst/>
                        </a:rPr>
                        <a:t>Ne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HT, 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39210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Whi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Mycoplasm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err="1">
                          <a:effectLst/>
                        </a:rPr>
                        <a:t>Mutlilobar</a:t>
                      </a:r>
                      <a:r>
                        <a:rPr lang="en-GB" sz="1000" u="none" strike="noStrike">
                          <a:effectLst/>
                        </a:rPr>
                        <a:t> </a:t>
                      </a:r>
                      <a:r>
                        <a:rPr lang="en-GB" sz="1000" u="none" strike="noStrike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haemoptysis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, </a:t>
                      </a:r>
                      <a:r>
                        <a:rPr lang="en-GB" sz="1000" u="none" strike="noStrike" dirty="0">
                          <a:effectLst/>
                        </a:rPr>
                        <a:t>fever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.3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0.3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eg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19803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M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Fevers, malaise, nause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5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8.4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os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HT, DM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29507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Whi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Cough, fevers, dyspnoe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21.5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8.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 smtClean="0">
                          <a:effectLst/>
                        </a:rPr>
                        <a:t>Ne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/>
                </a:tc>
              </a:tr>
              <a:tr h="29507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IS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>
                          <a:effectLst/>
                        </a:rPr>
                        <a:t>Multilobar</a:t>
                      </a:r>
                      <a:r>
                        <a:rPr lang="en-GB" sz="1000" u="none" strike="noStrike" dirty="0">
                          <a:effectLst/>
                        </a:rPr>
                        <a:t> </a:t>
                      </a:r>
                      <a:r>
                        <a:rPr lang="en-GB" sz="1000" u="none" strike="noStrike" dirty="0" smtClean="0">
                          <a:effectLst/>
                        </a:rPr>
                        <a:t>conso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chest pain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, </a:t>
                      </a:r>
                      <a:r>
                        <a:rPr lang="en-GB" sz="1000" u="none" strike="noStrike" dirty="0">
                          <a:effectLst/>
                        </a:rPr>
                        <a:t>fever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50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2.3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4.8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>
                          <a:effectLst/>
                        </a:rPr>
                        <a:t>Ne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507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AVERAGE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3.5 symptoms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270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3.9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12.3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3.5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620" marR="5620" marT="5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6209196"/>
              </p:ext>
            </p:extLst>
          </p:nvPr>
        </p:nvGraphicFramePr>
        <p:xfrm>
          <a:off x="116632" y="4907460"/>
          <a:ext cx="6597352" cy="2599915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720080"/>
                <a:gridCol w="648072"/>
                <a:gridCol w="1224136"/>
                <a:gridCol w="1917138"/>
                <a:gridCol w="420056"/>
                <a:gridCol w="444765"/>
                <a:gridCol w="457120"/>
                <a:gridCol w="765985"/>
              </a:tblGrid>
              <a:tr h="28803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Ethnicity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Histology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Lung</a:t>
                      </a:r>
                      <a:r>
                        <a:rPr lang="en-GB" sz="1050" u="none" strike="noStrike" baseline="0" dirty="0" smtClean="0">
                          <a:effectLst/>
                        </a:rPr>
                        <a:t> Cancer Stage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Symptom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CRP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mg/L</a:t>
                      </a:r>
                      <a:endParaRPr lang="en-GB" sz="1200" b="1" i="0" u="none" strike="noStrike" dirty="0" smtClean="0">
                        <a:solidFill>
                          <a:schemeClr val="bg1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Lymph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err="1" smtClean="0">
                          <a:effectLst/>
                        </a:rPr>
                        <a:t>Neut</a:t>
                      </a:r>
                      <a:endParaRPr lang="en-GB" sz="1050" u="none" strike="noStrike" dirty="0" smtClean="0">
                        <a:effectLst/>
                      </a:endParaRP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u="none" strike="noStrike" dirty="0" smtClean="0">
                          <a:effectLst/>
                        </a:rPr>
                        <a:t>x10</a:t>
                      </a:r>
                      <a:r>
                        <a:rPr lang="en-GB" sz="9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900" u="none" strike="noStrike" baseline="0" dirty="0" smtClean="0">
                          <a:effectLst/>
                        </a:rPr>
                        <a:t>/L</a:t>
                      </a:r>
                      <a:endParaRPr lang="en-GB" sz="900" u="none" strike="noStrike" dirty="0" smtClean="0">
                        <a:solidFill>
                          <a:schemeClr val="bg1"/>
                        </a:solidFill>
                        <a:effectLst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Other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1664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Black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quamous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Weight </a:t>
                      </a:r>
                      <a:r>
                        <a:rPr lang="en-GB" sz="1000" u="none" strike="noStrike" dirty="0">
                          <a:effectLst/>
                        </a:rPr>
                        <a:t>loss, hemiparesi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8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7.3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1664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Whi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 smtClean="0">
                          <a:effectLst/>
                        </a:rPr>
                        <a:t>Ade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b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31207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Whit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arge cel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</a:t>
                      </a:r>
                      <a:r>
                        <a:rPr lang="en-GB" sz="1000" u="none" strike="noStrike" dirty="0" smtClean="0">
                          <a:effectLst/>
                        </a:rPr>
                        <a:t>weight </a:t>
                      </a:r>
                      <a:r>
                        <a:rPr lang="en-GB" sz="1000" u="none" strike="noStrike" dirty="0">
                          <a:effectLst/>
                        </a:rPr>
                        <a:t>loss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2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.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ex-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31207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Whit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arge cel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</a:t>
                      </a:r>
                      <a:r>
                        <a:rPr lang="en-GB" sz="1000" u="none" strike="noStrike" dirty="0" smtClean="0">
                          <a:effectLst/>
                        </a:rPr>
                        <a:t>weight </a:t>
                      </a:r>
                      <a:r>
                        <a:rPr lang="en-GB" sz="1000" u="none" strike="noStrike" dirty="0">
                          <a:effectLst/>
                        </a:rPr>
                        <a:t>loss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3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2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1.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moker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31207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Whit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arge cell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haemoptysis, </a:t>
                      </a:r>
                      <a:r>
                        <a:rPr lang="en-GB" sz="1000" u="none" strike="noStrike" dirty="0" smtClean="0">
                          <a:effectLst/>
                        </a:rPr>
                        <a:t>weight </a:t>
                      </a:r>
                      <a:r>
                        <a:rPr lang="en-GB" sz="1000" u="none" strike="noStrike" dirty="0">
                          <a:effectLst/>
                        </a:rPr>
                        <a:t>loss, sweat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6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5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1.0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ex-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1664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Whit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 smtClean="0">
                          <a:effectLst/>
                        </a:rPr>
                        <a:t>Ade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2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8.7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1664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Whit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 smtClean="0">
                          <a:effectLst/>
                        </a:rPr>
                        <a:t>Ade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</a:t>
                      </a:r>
                      <a:r>
                        <a:rPr lang="en-GB" sz="1000" u="none" strike="noStrike" dirty="0" smtClean="0">
                          <a:effectLst/>
                        </a:rPr>
                        <a:t>dyspnoe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5.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9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/>
                </a:tc>
              </a:tr>
              <a:tr h="36747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Whit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 smtClean="0">
                          <a:effectLst/>
                        </a:rPr>
                        <a:t>Ade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b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ough, haemoptysis, </a:t>
                      </a:r>
                      <a:r>
                        <a:rPr lang="en-GB" sz="1000" u="none" strike="noStrike" dirty="0" smtClean="0">
                          <a:effectLst/>
                        </a:rPr>
                        <a:t>weight </a:t>
                      </a:r>
                      <a:r>
                        <a:rPr lang="en-GB" sz="1000" u="none" strike="noStrike" dirty="0">
                          <a:effectLst/>
                        </a:rPr>
                        <a:t>loss, sweat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4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7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1.2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ex-smoke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632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AVERAG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3a-b</a:t>
                      </a:r>
                      <a:endParaRPr lang="en-GB" sz="105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</a:rPr>
                        <a:t>2.6 symptom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</a:rPr>
                        <a:t>63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</a:rPr>
                        <a:t>1.3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</a:rPr>
                        <a:t>9.2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935" marR="6935" marT="693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-48859" y="35496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C</a:t>
            </a:r>
            <a:endParaRPr lang="en-GB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-41517" y="4418692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D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421036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5259891"/>
              </p:ext>
            </p:extLst>
          </p:nvPr>
        </p:nvGraphicFramePr>
        <p:xfrm>
          <a:off x="35278" y="3767780"/>
          <a:ext cx="6858002" cy="138487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692697"/>
                <a:gridCol w="432048"/>
                <a:gridCol w="792088"/>
                <a:gridCol w="576064"/>
                <a:gridCol w="432048"/>
                <a:gridCol w="360040"/>
                <a:gridCol w="288032"/>
                <a:gridCol w="432048"/>
                <a:gridCol w="432048"/>
                <a:gridCol w="288032"/>
                <a:gridCol w="648072"/>
                <a:gridCol w="821107"/>
                <a:gridCol w="663678"/>
              </a:tblGrid>
              <a:tr h="228969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smtClean="0">
                          <a:effectLst/>
                        </a:rPr>
                        <a:t>AVERAGE</a:t>
                      </a:r>
                    </a:p>
                    <a:p>
                      <a:pPr algn="ctr" fontAlgn="b"/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+ve micro </a:t>
                      </a:r>
                      <a:r>
                        <a:rPr lang="en-GB" sz="1000" u="none" strike="noStrike" dirty="0">
                          <a:effectLst/>
                        </a:rPr>
                        <a:t>results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 with consolidation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. of Symptoms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ength </a:t>
                      </a:r>
                      <a:br>
                        <a:rPr lang="en-GB" sz="1000" u="none" strike="noStrike" dirty="0">
                          <a:effectLst/>
                        </a:rPr>
                      </a:br>
                      <a:r>
                        <a:rPr lang="en-GB" sz="1000" u="none" strike="noStrike" dirty="0">
                          <a:effectLst/>
                        </a:rPr>
                        <a:t>(days)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CURB65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CRP</a:t>
                      </a:r>
                    </a:p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mg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ymph x10</a:t>
                      </a:r>
                      <a:r>
                        <a:rPr lang="en-GB" sz="1000" u="none" strike="noStrike" baseline="30000" dirty="0">
                          <a:effectLst/>
                        </a:rPr>
                        <a:t>9</a:t>
                      </a:r>
                      <a:r>
                        <a:rPr lang="en-GB" sz="1000" u="none" strike="noStrike" dirty="0">
                          <a:effectLst/>
                        </a:rPr>
                        <a:t>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>
                          <a:effectLst/>
                        </a:rPr>
                        <a:t>Neut</a:t>
                      </a:r>
                      <a:r>
                        <a:rPr lang="en-GB" sz="1000" u="none" strike="noStrike" dirty="0">
                          <a:effectLst/>
                        </a:rPr>
                        <a:t> x10</a:t>
                      </a:r>
                      <a:r>
                        <a:rPr lang="en-GB" sz="1000" u="none" strike="noStrike" baseline="30000" dirty="0">
                          <a:effectLst/>
                        </a:rPr>
                        <a:t>9</a:t>
                      </a:r>
                      <a:r>
                        <a:rPr lang="en-GB" sz="1000" u="none" strike="noStrike" dirty="0">
                          <a:effectLst/>
                        </a:rPr>
                        <a:t>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QFT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Co-morbidities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IV Antibiotics </a:t>
                      </a:r>
                      <a:br>
                        <a:rPr lang="en-GB" sz="1000" u="none" strike="noStrike" dirty="0">
                          <a:effectLst/>
                        </a:rPr>
                      </a:br>
                      <a:r>
                        <a:rPr lang="en-GB" sz="1000" u="none" strike="noStrike" dirty="0">
                          <a:effectLst/>
                        </a:rPr>
                        <a:t>before blood test </a:t>
                      </a:r>
                      <a:r>
                        <a:rPr lang="en-GB" sz="1000" u="none" strike="noStrike" dirty="0" smtClean="0">
                          <a:effectLst/>
                        </a:rPr>
                        <a:t>(doses</a:t>
                      </a:r>
                      <a:r>
                        <a:rPr lang="en-GB" sz="1000" u="none" strike="noStrike" dirty="0">
                          <a:effectLst/>
                        </a:rPr>
                        <a:t>)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Oral Antibiotics </a:t>
                      </a:r>
                      <a:br>
                        <a:rPr lang="en-GB" sz="1000" u="none" strike="noStrike" dirty="0">
                          <a:effectLst/>
                        </a:rPr>
                      </a:br>
                      <a:r>
                        <a:rPr lang="en-GB" sz="1000" u="none" strike="noStrike" dirty="0">
                          <a:effectLst/>
                        </a:rPr>
                        <a:t>before </a:t>
                      </a:r>
                      <a:r>
                        <a:rPr lang="en-GB" sz="1000" u="none" strike="noStrike" dirty="0" smtClean="0">
                          <a:effectLst/>
                        </a:rPr>
                        <a:t>test </a:t>
                      </a:r>
                      <a:r>
                        <a:rPr lang="en-GB" sz="1000" u="none" strike="noStrike" dirty="0">
                          <a:effectLst/>
                        </a:rPr>
                        <a:t>(days)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</a:tr>
              <a:tr h="14932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Pneumonia Trainin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0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/>
                </a:tc>
              </a:tr>
              <a:tr h="22233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Pneumonia Tes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3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6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13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7.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.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3.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96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&lt;0.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3318" marR="3318" marT="33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9745100"/>
              </p:ext>
            </p:extLst>
          </p:nvPr>
        </p:nvGraphicFramePr>
        <p:xfrm>
          <a:off x="34325" y="2113485"/>
          <a:ext cx="6794625" cy="1016683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171476"/>
                <a:gridCol w="1080120"/>
                <a:gridCol w="864096"/>
                <a:gridCol w="743240"/>
                <a:gridCol w="778010"/>
                <a:gridCol w="663902"/>
                <a:gridCol w="497927"/>
                <a:gridCol w="497927"/>
                <a:gridCol w="497927"/>
              </a:tblGrid>
              <a:tr h="39012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AVERAGE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ength of disease (months)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. of symptoms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XR stage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 of co-morbidities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. positive QFT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ymph x10</a:t>
                      </a:r>
                      <a:r>
                        <a:rPr lang="en-GB" sz="1000" u="none" strike="noStrike" baseline="30000" dirty="0">
                          <a:effectLst/>
                        </a:rPr>
                        <a:t>9</a:t>
                      </a:r>
                      <a:r>
                        <a:rPr lang="en-GB" sz="1000" u="none" strike="noStrike" dirty="0">
                          <a:effectLst/>
                        </a:rPr>
                        <a:t>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>
                          <a:effectLst/>
                        </a:rPr>
                        <a:t>Neut</a:t>
                      </a:r>
                      <a:r>
                        <a:rPr lang="en-GB" sz="1000" u="none" strike="noStrike" dirty="0">
                          <a:effectLst/>
                        </a:rPr>
                        <a:t> x10</a:t>
                      </a:r>
                      <a:r>
                        <a:rPr lang="en-GB" sz="1000" u="none" strike="noStrike" baseline="30000" dirty="0">
                          <a:effectLst/>
                        </a:rPr>
                        <a:t>9</a:t>
                      </a:r>
                      <a:r>
                        <a:rPr lang="en-GB" sz="1000" u="none" strike="noStrike" dirty="0">
                          <a:effectLst/>
                        </a:rPr>
                        <a:t>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ACE IU/m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</a:tr>
              <a:tr h="1356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Sarcoidosis Trainin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6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.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.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95.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/>
                </a:tc>
              </a:tr>
              <a:tr h="1356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Sarcoidosis Test </a:t>
                      </a:r>
                      <a:r>
                        <a:rPr lang="en-GB" sz="1000" u="none" strike="noStrike" dirty="0">
                          <a:effectLst/>
                        </a:rPr>
                        <a:t>&amp; Validation 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9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3.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84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69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p&lt;0.0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654" marR="5654" marT="565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2252858"/>
              </p:ext>
            </p:extLst>
          </p:nvPr>
        </p:nvGraphicFramePr>
        <p:xfrm>
          <a:off x="44624" y="5784004"/>
          <a:ext cx="6741369" cy="109225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674306"/>
                <a:gridCol w="674306"/>
                <a:gridCol w="1256008"/>
                <a:gridCol w="919277"/>
                <a:gridCol w="612852"/>
                <a:gridCol w="689458"/>
                <a:gridCol w="635670"/>
                <a:gridCol w="1279492"/>
              </a:tblGrid>
              <a:tr h="15271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>
                          <a:effectLst/>
                        </a:rPr>
                        <a:t>AVERAGE</a:t>
                      </a:r>
                      <a:endParaRPr lang="en-GB" sz="105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Histology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Lung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Cancer Stage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u="none" strike="noStrike" dirty="0" smtClean="0">
                          <a:effectLst/>
                        </a:rPr>
                        <a:t>Symptoms</a:t>
                      </a:r>
                      <a:endParaRPr lang="en-GB" sz="105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CRP</a:t>
                      </a:r>
                    </a:p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mg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Lymph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smtClean="0">
                          <a:effectLst/>
                        </a:rPr>
                        <a:t>x10</a:t>
                      </a:r>
                      <a:r>
                        <a:rPr lang="en-GB" sz="10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1000" u="none" strike="noStrike" dirty="0" smtClean="0">
                          <a:effectLst/>
                        </a:rPr>
                        <a:t>/L</a:t>
                      </a:r>
                      <a:endParaRPr lang="en-GB" sz="1000" b="1" i="0" u="none" strike="noStrike" dirty="0" smtClean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 smtClean="0">
                          <a:effectLst/>
                        </a:rPr>
                        <a:t>Neut</a:t>
                      </a:r>
                      <a:endParaRPr lang="en-GB" sz="1000" u="none" strike="noStrike" dirty="0" smtClean="0">
                        <a:effectLst/>
                      </a:endParaRP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smtClean="0">
                          <a:effectLst/>
                        </a:rPr>
                        <a:t>x10</a:t>
                      </a:r>
                      <a:r>
                        <a:rPr lang="en-GB" sz="10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1000" u="none" strike="noStrike" dirty="0" smtClean="0">
                          <a:effectLst/>
                        </a:rPr>
                        <a:t>/L</a:t>
                      </a:r>
                      <a:endParaRPr lang="en-GB" sz="1000" b="1" i="0" u="none" strike="noStrike" dirty="0" smtClean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Smoker/Ex-smoker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</a:tr>
              <a:tr h="15271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Lung Cancer Trainin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 typ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a-b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8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9.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.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363" marR="6363" marT="6363" marB="0" anchor="ctr"/>
                </a:tc>
              </a:tr>
              <a:tr h="15271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Lung</a:t>
                      </a:r>
                      <a:r>
                        <a:rPr lang="en-GB" sz="1000" u="none" strike="noStrike" baseline="0" dirty="0" smtClean="0">
                          <a:effectLst/>
                        </a:rPr>
                        <a:t> Cancer </a:t>
                      </a:r>
                      <a:r>
                        <a:rPr lang="en-GB" sz="1000" u="none" strike="noStrike" dirty="0" smtClean="0">
                          <a:effectLst/>
                        </a:rPr>
                        <a:t>Tes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 typ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3b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.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5.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.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363" marR="6363" marT="636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271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&lt;0.05</a:t>
                      </a:r>
                      <a:endParaRPr lang="en-GB" sz="1000" b="0" i="1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Y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363" marR="6363" marT="636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638659"/>
              </p:ext>
            </p:extLst>
          </p:nvPr>
        </p:nvGraphicFramePr>
        <p:xfrm>
          <a:off x="0" y="395536"/>
          <a:ext cx="6858001" cy="1081253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599653"/>
                <a:gridCol w="597101"/>
                <a:gridCol w="1440160"/>
                <a:gridCol w="648072"/>
                <a:gridCol w="1224136"/>
                <a:gridCol w="504056"/>
                <a:gridCol w="504056"/>
                <a:gridCol w="576064"/>
                <a:gridCol w="764703"/>
              </a:tblGrid>
              <a:tr h="1231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AVERAGE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Sputum </a:t>
                      </a:r>
                      <a:r>
                        <a:rPr lang="en-GB" sz="1000" u="none" strike="noStrike" dirty="0" smtClean="0">
                          <a:effectLst/>
                        </a:rPr>
                        <a:t>smear +ve 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CXR result 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 of Symptoms 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Symptom length (months)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CRP mg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Lymph x10</a:t>
                      </a:r>
                      <a:r>
                        <a:rPr lang="en-GB" sz="10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1000" u="none" strike="noStrike" dirty="0" smtClean="0">
                          <a:effectLst/>
                        </a:rPr>
                        <a:t>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err="1" smtClean="0">
                          <a:effectLst/>
                        </a:rPr>
                        <a:t>Neut</a:t>
                      </a:r>
                      <a:r>
                        <a:rPr lang="en-GB" sz="1000" u="none" strike="noStrike" dirty="0" smtClean="0">
                          <a:effectLst/>
                        </a:rPr>
                        <a:t> x10</a:t>
                      </a:r>
                      <a:r>
                        <a:rPr lang="en-GB" sz="1000" u="none" strike="noStrike" baseline="30000" dirty="0" smtClean="0">
                          <a:effectLst/>
                        </a:rPr>
                        <a:t>9</a:t>
                      </a:r>
                      <a:r>
                        <a:rPr lang="en-GB" sz="1000" u="none" strike="noStrike" dirty="0" smtClean="0">
                          <a:effectLst/>
                        </a:rPr>
                        <a:t>/L</a:t>
                      </a:r>
                      <a:endParaRPr lang="en-GB" sz="10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 of co-morbidities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</a:tr>
              <a:tr h="30557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TB Trainin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69%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5% densities, 50% cavities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.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/>
                </a:tc>
              </a:tr>
              <a:tr h="30557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TB Test </a:t>
                      </a:r>
                      <a:r>
                        <a:rPr lang="en-GB" sz="1000" u="none" strike="noStrike" dirty="0">
                          <a:effectLst/>
                        </a:rPr>
                        <a:t>&amp; Valid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45%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78% densities, 44% caviti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.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7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7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p&lt;0.05</a:t>
                      </a:r>
                      <a:endParaRPr lang="en-GB" sz="1000" b="0" i="1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Yes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No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61" marR="4561" marT="45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-41517" y="26204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E</a:t>
            </a:r>
            <a:endParaRPr lang="en-GB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-50534" y="1754396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F</a:t>
            </a:r>
            <a:endParaRPr lang="en-GB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-27384" y="3459438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G</a:t>
            </a:r>
            <a:endParaRPr lang="en-GB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-27384" y="5436096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2H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661343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47</Words>
  <Application>Microsoft Office PowerPoint</Application>
  <PresentationFormat>On-screen Show (4:3)</PresentationFormat>
  <Paragraphs>804</Paragraphs>
  <Slides>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2</cp:revision>
  <dcterms:created xsi:type="dcterms:W3CDTF">2013-03-09T22:22:05Z</dcterms:created>
  <dcterms:modified xsi:type="dcterms:W3CDTF">2013-03-09T22:23:57Z</dcterms:modified>
</cp:coreProperties>
</file>